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80" r:id="rId2"/>
    <p:sldId id="278" r:id="rId3"/>
    <p:sldId id="274" r:id="rId4"/>
    <p:sldId id="275" r:id="rId5"/>
    <p:sldId id="276" r:id="rId6"/>
    <p:sldId id="281" r:id="rId7"/>
    <p:sldId id="273" r:id="rId8"/>
    <p:sldId id="277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29C2DD-F2C8-4046-BC70-832235E22199}" v="183" dt="2020-11-05T11:13:29.99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445"/>
    <p:restoredTop sz="94672"/>
  </p:normalViewPr>
  <p:slideViewPr>
    <p:cSldViewPr snapToGrid="0" snapToObjects="1">
      <p:cViewPr>
        <p:scale>
          <a:sx n="70" d="100"/>
          <a:sy n="70" d="100"/>
        </p:scale>
        <p:origin x="826" y="3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en, Yuzhi" userId="5cad3a37-45c4-44dd-9cb2-6f9e490cbde9" providerId="ADAL" clId="{1029C2DD-F2C8-4046-BC70-832235E22199}"/>
    <pc:docChg chg="undo custSel addSld delSld modSld sldOrd">
      <pc:chgData name="Chen, Yuzhi" userId="5cad3a37-45c4-44dd-9cb2-6f9e490cbde9" providerId="ADAL" clId="{1029C2DD-F2C8-4046-BC70-832235E22199}" dt="2020-11-05T11:18:38.892" v="362" actId="108"/>
      <pc:docMkLst>
        <pc:docMk/>
      </pc:docMkLst>
      <pc:sldChg chg="modSp mod">
        <pc:chgData name="Chen, Yuzhi" userId="5cad3a37-45c4-44dd-9cb2-6f9e490cbde9" providerId="ADAL" clId="{1029C2DD-F2C8-4046-BC70-832235E22199}" dt="2020-11-05T11:14:21.425" v="270" actId="20577"/>
        <pc:sldMkLst>
          <pc:docMk/>
          <pc:sldMk cId="1255330696" sldId="273"/>
        </pc:sldMkLst>
        <pc:spChg chg="mod">
          <ac:chgData name="Chen, Yuzhi" userId="5cad3a37-45c4-44dd-9cb2-6f9e490cbde9" providerId="ADAL" clId="{1029C2DD-F2C8-4046-BC70-832235E22199}" dt="2020-11-05T11:14:21.425" v="270" actId="20577"/>
          <ac:spMkLst>
            <pc:docMk/>
            <pc:sldMk cId="1255330696" sldId="273"/>
            <ac:spMk id="38" creationId="{D224F1A0-1D66-044D-AA1D-2BF61794F035}"/>
          </ac:spMkLst>
        </pc:spChg>
      </pc:sldChg>
      <pc:sldChg chg="modSp mod">
        <pc:chgData name="Chen, Yuzhi" userId="5cad3a37-45c4-44dd-9cb2-6f9e490cbde9" providerId="ADAL" clId="{1029C2DD-F2C8-4046-BC70-832235E22199}" dt="2020-11-02T16:53:06.114" v="222" actId="20577"/>
        <pc:sldMkLst>
          <pc:docMk/>
          <pc:sldMk cId="3540507534" sldId="274"/>
        </pc:sldMkLst>
        <pc:spChg chg="mod">
          <ac:chgData name="Chen, Yuzhi" userId="5cad3a37-45c4-44dd-9cb2-6f9e490cbde9" providerId="ADAL" clId="{1029C2DD-F2C8-4046-BC70-832235E22199}" dt="2020-11-02T16:53:03.076" v="220" actId="20577"/>
          <ac:spMkLst>
            <pc:docMk/>
            <pc:sldMk cId="3540507534" sldId="274"/>
            <ac:spMk id="7" creationId="{E9620E69-934A-C642-A49A-0ACC4C2C32B0}"/>
          </ac:spMkLst>
        </pc:spChg>
        <pc:spChg chg="mod">
          <ac:chgData name="Chen, Yuzhi" userId="5cad3a37-45c4-44dd-9cb2-6f9e490cbde9" providerId="ADAL" clId="{1029C2DD-F2C8-4046-BC70-832235E22199}" dt="2020-11-02T16:53:06.114" v="222" actId="20577"/>
          <ac:spMkLst>
            <pc:docMk/>
            <pc:sldMk cId="3540507534" sldId="274"/>
            <ac:spMk id="10" creationId="{31C42944-3D68-6946-A8B0-ABEFFBBF6D0D}"/>
          </ac:spMkLst>
        </pc:spChg>
      </pc:sldChg>
      <pc:sldChg chg="modSp mod">
        <pc:chgData name="Chen, Yuzhi" userId="5cad3a37-45c4-44dd-9cb2-6f9e490cbde9" providerId="ADAL" clId="{1029C2DD-F2C8-4046-BC70-832235E22199}" dt="2020-11-02T16:53:14.738" v="224" actId="20577"/>
        <pc:sldMkLst>
          <pc:docMk/>
          <pc:sldMk cId="3131842838" sldId="275"/>
        </pc:sldMkLst>
        <pc:spChg chg="mod">
          <ac:chgData name="Chen, Yuzhi" userId="5cad3a37-45c4-44dd-9cb2-6f9e490cbde9" providerId="ADAL" clId="{1029C2DD-F2C8-4046-BC70-832235E22199}" dt="2020-11-02T16:53:14.738" v="224" actId="20577"/>
          <ac:spMkLst>
            <pc:docMk/>
            <pc:sldMk cId="3131842838" sldId="275"/>
            <ac:spMk id="9" creationId="{002D2753-2AA1-EC4C-B287-35C647807C98}"/>
          </ac:spMkLst>
        </pc:spChg>
      </pc:sldChg>
      <pc:sldChg chg="modSp mod">
        <pc:chgData name="Chen, Yuzhi" userId="5cad3a37-45c4-44dd-9cb2-6f9e490cbde9" providerId="ADAL" clId="{1029C2DD-F2C8-4046-BC70-832235E22199}" dt="2020-11-03T10:15:55.425" v="245" actId="313"/>
        <pc:sldMkLst>
          <pc:docMk/>
          <pc:sldMk cId="477919732" sldId="276"/>
        </pc:sldMkLst>
        <pc:spChg chg="mod">
          <ac:chgData name="Chen, Yuzhi" userId="5cad3a37-45c4-44dd-9cb2-6f9e490cbde9" providerId="ADAL" clId="{1029C2DD-F2C8-4046-BC70-832235E22199}" dt="2020-11-03T10:15:55.425" v="245" actId="313"/>
          <ac:spMkLst>
            <pc:docMk/>
            <pc:sldMk cId="477919732" sldId="276"/>
            <ac:spMk id="11" creationId="{DADC6A0B-0D18-2245-8255-44BE8D0E4288}"/>
          </ac:spMkLst>
        </pc:spChg>
      </pc:sldChg>
      <pc:sldChg chg="modSp mod">
        <pc:chgData name="Chen, Yuzhi" userId="5cad3a37-45c4-44dd-9cb2-6f9e490cbde9" providerId="ADAL" clId="{1029C2DD-F2C8-4046-BC70-832235E22199}" dt="2020-11-05T11:14:26.347" v="273" actId="20577"/>
        <pc:sldMkLst>
          <pc:docMk/>
          <pc:sldMk cId="1168509248" sldId="277"/>
        </pc:sldMkLst>
        <pc:spChg chg="mod">
          <ac:chgData name="Chen, Yuzhi" userId="5cad3a37-45c4-44dd-9cb2-6f9e490cbde9" providerId="ADAL" clId="{1029C2DD-F2C8-4046-BC70-832235E22199}" dt="2020-11-05T11:14:26.347" v="273" actId="20577"/>
          <ac:spMkLst>
            <pc:docMk/>
            <pc:sldMk cId="1168509248" sldId="277"/>
            <ac:spMk id="10" creationId="{D2AAA551-CEC3-6946-A6A4-7AFDFF453F14}"/>
          </ac:spMkLst>
        </pc:spChg>
      </pc:sldChg>
      <pc:sldChg chg="modSp mod ord">
        <pc:chgData name="Chen, Yuzhi" userId="5cad3a37-45c4-44dd-9cb2-6f9e490cbde9" providerId="ADAL" clId="{1029C2DD-F2C8-4046-BC70-832235E22199}" dt="2020-11-03T10:12:11.857" v="240" actId="20577"/>
        <pc:sldMkLst>
          <pc:docMk/>
          <pc:sldMk cId="4079315433" sldId="278"/>
        </pc:sldMkLst>
        <pc:spChg chg="mod">
          <ac:chgData name="Chen, Yuzhi" userId="5cad3a37-45c4-44dd-9cb2-6f9e490cbde9" providerId="ADAL" clId="{1029C2DD-F2C8-4046-BC70-832235E22199}" dt="2020-11-03T10:12:11.857" v="240" actId="20577"/>
          <ac:spMkLst>
            <pc:docMk/>
            <pc:sldMk cId="4079315433" sldId="278"/>
            <ac:spMk id="6" creationId="{45B99CCA-4AD1-1143-9D97-EE0F835D8364}"/>
          </ac:spMkLst>
        </pc:spChg>
      </pc:sldChg>
      <pc:sldChg chg="addSp delSp modSp new del mod">
        <pc:chgData name="Chen, Yuzhi" userId="5cad3a37-45c4-44dd-9cb2-6f9e490cbde9" providerId="ADAL" clId="{1029C2DD-F2C8-4046-BC70-832235E22199}" dt="2020-11-02T16:42:31.526" v="198" actId="2696"/>
        <pc:sldMkLst>
          <pc:docMk/>
          <pc:sldMk cId="1665148993" sldId="279"/>
        </pc:sldMkLst>
        <pc:spChg chg="del">
          <ac:chgData name="Chen, Yuzhi" userId="5cad3a37-45c4-44dd-9cb2-6f9e490cbde9" providerId="ADAL" clId="{1029C2DD-F2C8-4046-BC70-832235E22199}" dt="2020-11-02T16:28:56.207" v="1" actId="478"/>
          <ac:spMkLst>
            <pc:docMk/>
            <pc:sldMk cId="1665148993" sldId="279"/>
            <ac:spMk id="2" creationId="{7EA38A52-BDB4-4C6E-BDC2-CA5020484B6D}"/>
          </ac:spMkLst>
        </pc:spChg>
        <pc:spChg chg="del">
          <ac:chgData name="Chen, Yuzhi" userId="5cad3a37-45c4-44dd-9cb2-6f9e490cbde9" providerId="ADAL" clId="{1029C2DD-F2C8-4046-BC70-832235E22199}" dt="2020-11-02T16:28:56.207" v="1" actId="478"/>
          <ac:spMkLst>
            <pc:docMk/>
            <pc:sldMk cId="1665148993" sldId="279"/>
            <ac:spMk id="3" creationId="{F958C811-57AB-4A72-993B-022D95B5EC97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18" creationId="{CFC003FA-5D15-4F9F-9E69-D687D3371056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19" creationId="{F7639830-FABE-474C-94AE-E2556D307A7E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0" creationId="{049BAA7B-5C03-406C-9A17-E1EAC7E6F31D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1" creationId="{C0502450-92D2-4F1B-A05E-7A949C259DD5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2" creationId="{E6FE46DC-76A9-4A57-B803-CF3A0DB777A8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3" creationId="{5192BF23-A7DF-47E4-A36B-840FB0416C7E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4" creationId="{D4728D98-8255-4A66-9F79-1C1EE99B5486}"/>
          </ac:spMkLst>
        </pc:spChg>
        <pc:spChg chg="add mod">
          <ac:chgData name="Chen, Yuzhi" userId="5cad3a37-45c4-44dd-9cb2-6f9e490cbde9" providerId="ADAL" clId="{1029C2DD-F2C8-4046-BC70-832235E22199}" dt="2020-11-02T16:40:29.653" v="182" actId="1036"/>
          <ac:spMkLst>
            <pc:docMk/>
            <pc:sldMk cId="1665148993" sldId="279"/>
            <ac:spMk id="25" creationId="{5A9114CD-567D-4E45-B3D9-1CB8F9C9160E}"/>
          </ac:spMkLst>
        </pc:spChg>
        <pc:spChg chg="add mod">
          <ac:chgData name="Chen, Yuzhi" userId="5cad3a37-45c4-44dd-9cb2-6f9e490cbde9" providerId="ADAL" clId="{1029C2DD-F2C8-4046-BC70-832235E22199}" dt="2020-11-02T16:30:17.039" v="8" actId="1076"/>
          <ac:spMkLst>
            <pc:docMk/>
            <pc:sldMk cId="1665148993" sldId="279"/>
            <ac:spMk id="26" creationId="{ACC32289-CAEA-4FBE-90EA-F7CD2C39C2FE}"/>
          </ac:spMkLst>
        </pc:spChg>
        <pc:spChg chg="add mod">
          <ac:chgData name="Chen, Yuzhi" userId="5cad3a37-45c4-44dd-9cb2-6f9e490cbde9" providerId="ADAL" clId="{1029C2DD-F2C8-4046-BC70-832235E22199}" dt="2020-11-02T16:30:17.039" v="8" actId="1076"/>
          <ac:spMkLst>
            <pc:docMk/>
            <pc:sldMk cId="1665148993" sldId="279"/>
            <ac:spMk id="27" creationId="{429D7656-2939-4524-BDE8-501C6FD2BD11}"/>
          </ac:spMkLst>
        </pc:spChg>
        <pc:spChg chg="add mod">
          <ac:chgData name="Chen, Yuzhi" userId="5cad3a37-45c4-44dd-9cb2-6f9e490cbde9" providerId="ADAL" clId="{1029C2DD-F2C8-4046-BC70-832235E22199}" dt="2020-11-02T16:30:17.039" v="8" actId="1076"/>
          <ac:spMkLst>
            <pc:docMk/>
            <pc:sldMk cId="1665148993" sldId="279"/>
            <ac:spMk id="28" creationId="{BB6F8622-3159-4AAE-9E29-A21E915EAAF4}"/>
          </ac:spMkLst>
        </pc:spChg>
        <pc:grpChg chg="add mod">
          <ac:chgData name="Chen, Yuzhi" userId="5cad3a37-45c4-44dd-9cb2-6f9e490cbde9" providerId="ADAL" clId="{1029C2DD-F2C8-4046-BC70-832235E22199}" dt="2020-11-02T16:29:35.655" v="6" actId="1076"/>
          <ac:grpSpMkLst>
            <pc:docMk/>
            <pc:sldMk cId="1665148993" sldId="279"/>
            <ac:grpSpMk id="5" creationId="{CCA5A4C5-D90C-43E9-8B2E-573146DECBB0}"/>
          </ac:grpSpMkLst>
        </pc:grpChg>
        <pc:picChg chg="add mod">
          <ac:chgData name="Chen, Yuzhi" userId="5cad3a37-45c4-44dd-9cb2-6f9e490cbde9" providerId="ADAL" clId="{1029C2DD-F2C8-4046-BC70-832235E22199}" dt="2020-11-02T16:29:12.465" v="3"/>
          <ac:picMkLst>
            <pc:docMk/>
            <pc:sldMk cId="1665148993" sldId="279"/>
            <ac:picMk id="4" creationId="{D1841787-44C3-4480-B94D-D36614CF3F08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6" creationId="{59F7E36A-5344-4CE4-8B6A-DD94FDCDA9D4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7" creationId="{E8CD12C1-CD5C-4E61-9891-67EFC6B79FE7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8" creationId="{8DC23D19-6667-43FD-9DAA-3E33DD6FCE53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9" creationId="{5575809E-B6C3-4820-9440-831E3EE67DA6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0" creationId="{D7316A64-845C-4BFF-B781-5815CE10AFA3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1" creationId="{101DF4F8-391B-4AD0-82EE-2F775B46AA40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2" creationId="{21FB1F84-22EF-4323-9210-EDF3E2184294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3" creationId="{93839F46-AC7C-4407-B04E-258905C7BD04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4" creationId="{E66D1EE9-6DA2-4446-9925-2D18C35E6908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5" creationId="{4BEB8E98-9B8F-4928-A4D0-104C24701693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6" creationId="{881323D0-9BC4-4487-9479-5EF25D73A61A}"/>
          </ac:picMkLst>
        </pc:picChg>
        <pc:picChg chg="add mod">
          <ac:chgData name="Chen, Yuzhi" userId="5cad3a37-45c4-44dd-9cb2-6f9e490cbde9" providerId="ADAL" clId="{1029C2DD-F2C8-4046-BC70-832235E22199}" dt="2020-11-02T16:29:22.937" v="4"/>
          <ac:picMkLst>
            <pc:docMk/>
            <pc:sldMk cId="1665148993" sldId="279"/>
            <ac:picMk id="17" creationId="{AE8ACF3B-C4D2-4B56-92C1-1BAFB99A8635}"/>
          </ac:picMkLst>
        </pc:picChg>
        <pc:picChg chg="add mod">
          <ac:chgData name="Chen, Yuzhi" userId="5cad3a37-45c4-44dd-9cb2-6f9e490cbde9" providerId="ADAL" clId="{1029C2DD-F2C8-4046-BC70-832235E22199}" dt="2020-11-02T16:40:29.653" v="182" actId="1036"/>
          <ac:picMkLst>
            <pc:docMk/>
            <pc:sldMk cId="1665148993" sldId="279"/>
            <ac:picMk id="2049" creationId="{1FA5A14B-8F4B-4227-A18B-C440B81DE454}"/>
          </ac:picMkLst>
        </pc:picChg>
      </pc:sldChg>
      <pc:sldChg chg="addSp delSp modSp new mod ord">
        <pc:chgData name="Chen, Yuzhi" userId="5cad3a37-45c4-44dd-9cb2-6f9e490cbde9" providerId="ADAL" clId="{1029C2DD-F2C8-4046-BC70-832235E22199}" dt="2020-11-03T10:13:14.370" v="242" actId="114"/>
        <pc:sldMkLst>
          <pc:docMk/>
          <pc:sldMk cId="347819172" sldId="280"/>
        </pc:sldMkLst>
        <pc:spChg chg="del">
          <ac:chgData name="Chen, Yuzhi" userId="5cad3a37-45c4-44dd-9cb2-6f9e490cbde9" providerId="ADAL" clId="{1029C2DD-F2C8-4046-BC70-832235E22199}" dt="2020-11-02T16:41:21.549" v="184" actId="478"/>
          <ac:spMkLst>
            <pc:docMk/>
            <pc:sldMk cId="347819172" sldId="280"/>
            <ac:spMk id="2" creationId="{B8A06A70-FAB6-413B-B8FD-1DFFD74F6F35}"/>
          </ac:spMkLst>
        </pc:spChg>
        <pc:spChg chg="del">
          <ac:chgData name="Chen, Yuzhi" userId="5cad3a37-45c4-44dd-9cb2-6f9e490cbde9" providerId="ADAL" clId="{1029C2DD-F2C8-4046-BC70-832235E22199}" dt="2020-11-02T16:41:21.549" v="184" actId="478"/>
          <ac:spMkLst>
            <pc:docMk/>
            <pc:sldMk cId="347819172" sldId="280"/>
            <ac:spMk id="3" creationId="{6E5461B7-45A8-4634-A093-580B66BAB4F8}"/>
          </ac:spMkLst>
        </pc:spChg>
        <pc:spChg chg="add mod">
          <ac:chgData name="Chen, Yuzhi" userId="5cad3a37-45c4-44dd-9cb2-6f9e490cbde9" providerId="ADAL" clId="{1029C2DD-F2C8-4046-BC70-832235E22199}" dt="2020-11-03T10:13:14.370" v="242" actId="114"/>
          <ac:spMkLst>
            <pc:docMk/>
            <pc:sldMk cId="347819172" sldId="280"/>
            <ac:spMk id="8" creationId="{ACFDBCE1-27B0-4F4F-97F9-D8B414F597E8}"/>
          </ac:spMkLst>
        </pc:spChg>
        <pc:spChg chg="add mod">
          <ac:chgData name="Chen, Yuzhi" userId="5cad3a37-45c4-44dd-9cb2-6f9e490cbde9" providerId="ADAL" clId="{1029C2DD-F2C8-4046-BC70-832235E22199}" dt="2020-11-03T10:12:07.802" v="238" actId="20577"/>
          <ac:spMkLst>
            <pc:docMk/>
            <pc:sldMk cId="347819172" sldId="280"/>
            <ac:spMk id="10" creationId="{F9BB1940-1ABE-43A1-AD70-1B7AF58E9401}"/>
          </ac:spMkLst>
        </pc:spChg>
        <pc:picChg chg="add mod">
          <ac:chgData name="Chen, Yuzhi" userId="5cad3a37-45c4-44dd-9cb2-6f9e490cbde9" providerId="ADAL" clId="{1029C2DD-F2C8-4046-BC70-832235E22199}" dt="2020-11-02T16:44:06.823" v="209" actId="1076"/>
          <ac:picMkLst>
            <pc:docMk/>
            <pc:sldMk cId="347819172" sldId="280"/>
            <ac:picMk id="5" creationId="{E1952CE8-DBFD-49F7-9ED2-9AC6DF1B48F0}"/>
          </ac:picMkLst>
        </pc:picChg>
        <pc:picChg chg="add mod">
          <ac:chgData name="Chen, Yuzhi" userId="5cad3a37-45c4-44dd-9cb2-6f9e490cbde9" providerId="ADAL" clId="{1029C2DD-F2C8-4046-BC70-832235E22199}" dt="2020-11-02T16:42:23.085" v="196" actId="1076"/>
          <ac:picMkLst>
            <pc:docMk/>
            <pc:sldMk cId="347819172" sldId="280"/>
            <ac:picMk id="7" creationId="{9DE48FAD-02B7-46B0-9651-850BAA106943}"/>
          </ac:picMkLst>
        </pc:picChg>
      </pc:sldChg>
      <pc:sldChg chg="addSp delSp modSp new mod">
        <pc:chgData name="Chen, Yuzhi" userId="5cad3a37-45c4-44dd-9cb2-6f9e490cbde9" providerId="ADAL" clId="{1029C2DD-F2C8-4046-BC70-832235E22199}" dt="2020-11-05T11:18:38.892" v="362" actId="108"/>
        <pc:sldMkLst>
          <pc:docMk/>
          <pc:sldMk cId="1309097890" sldId="281"/>
        </pc:sldMkLst>
        <pc:spChg chg="del">
          <ac:chgData name="Chen, Yuzhi" userId="5cad3a37-45c4-44dd-9cb2-6f9e490cbde9" providerId="ADAL" clId="{1029C2DD-F2C8-4046-BC70-832235E22199}" dt="2020-11-05T11:13:07.450" v="251" actId="478"/>
          <ac:spMkLst>
            <pc:docMk/>
            <pc:sldMk cId="1309097890" sldId="281"/>
            <ac:spMk id="2" creationId="{11C9C5FC-A635-41E5-B75E-5B91AE064AF2}"/>
          </ac:spMkLst>
        </pc:spChg>
        <pc:spChg chg="del">
          <ac:chgData name="Chen, Yuzhi" userId="5cad3a37-45c4-44dd-9cb2-6f9e490cbde9" providerId="ADAL" clId="{1029C2DD-F2C8-4046-BC70-832235E22199}" dt="2020-11-05T11:13:07.450" v="251" actId="478"/>
          <ac:spMkLst>
            <pc:docMk/>
            <pc:sldMk cId="1309097890" sldId="281"/>
            <ac:spMk id="3" creationId="{D493EC43-9E07-4B01-8041-A22D92CEE7EF}"/>
          </ac:spMkLst>
        </pc:spChg>
        <pc:spChg chg="add mod">
          <ac:chgData name="Chen, Yuzhi" userId="5cad3a37-45c4-44dd-9cb2-6f9e490cbde9" providerId="ADAL" clId="{1029C2DD-F2C8-4046-BC70-832235E22199}" dt="2020-11-05T11:18:38.892" v="362" actId="108"/>
          <ac:spMkLst>
            <pc:docMk/>
            <pc:sldMk cId="1309097890" sldId="281"/>
            <ac:spMk id="6" creationId="{E1F97C65-2BF8-4DAC-BE41-72335D4112DD}"/>
          </ac:spMkLst>
        </pc:spChg>
        <pc:graphicFrameChg chg="add mod modGraphic">
          <ac:chgData name="Chen, Yuzhi" userId="5cad3a37-45c4-44dd-9cb2-6f9e490cbde9" providerId="ADAL" clId="{1029C2DD-F2C8-4046-BC70-832235E22199}" dt="2020-11-05T11:13:58.473" v="260" actId="1076"/>
          <ac:graphicFrameMkLst>
            <pc:docMk/>
            <pc:sldMk cId="1309097890" sldId="281"/>
            <ac:graphicFrameMk id="4" creationId="{235C4881-F3DA-44EF-BC9D-DDD406D40FA8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202626-EFB4-F745-A797-815375A889F1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8FB42C-2A37-1946-94BB-115A42BCC6F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5482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CBC144-88E3-0646-90F4-1B19DFDD37CE}" type="slidenum">
              <a:rPr kumimoji="1" lang="zh-CN" altLang="en-US" smtClean="0"/>
              <a:t>7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729485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602459-A712-064A-BFC4-E7913F086A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EBA2803-E57B-EA4B-8F65-72A9D8C374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A5DC08-BB7E-1D45-8B81-4BC8CFC3F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0D14E5-CA04-BF42-9772-0847B6095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E82E7F-66D0-8747-8A82-ACA1E9487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81686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4A521D-433B-454D-9F59-18D2FAFB7F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A2ED30-602C-064A-9C4F-D13143C163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B1E6E1-C17C-3D48-9B8E-DC5F6DA62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0D9D0E-198A-9847-BE8D-778A4BB96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1A5E22-CF4C-E849-BF0E-E5BAB90E5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4880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610E4B5-3825-3B46-90CB-3CFF807946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872C4F5-9AF5-8C45-BF68-F88B096BE4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E89CE3-1CAC-A34E-93B4-B12AF2E71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0AB953-BE88-6247-A9FB-50B26CA2C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1C0A90-B7A5-4547-A012-0822C01BA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3442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F4730E-530B-4F41-959B-DB21065C2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E162FA3-78CB-4542-9C84-305FA8F1E6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490086-FECA-D149-9A99-0DB923A5B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23CF0A-B57D-4842-8802-8773EB36E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2BC098-3933-914F-B447-EFA949D32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5811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4701AD-7E09-4A4B-9AE0-B09C78DDB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9F56CC-E866-F04A-8157-0ACB81B871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6D8A37-9A42-C644-8F82-60670BC09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8FBFEF-6A05-7C4E-8695-9796798D0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4CA8D5-E71B-EC46-AA75-0FE214492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6384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5B53F7-4B0A-3941-809D-8CB2F53C15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B41997-8193-184C-BC59-31D430A8DE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3DA3CC1-4FFD-C142-8C4E-E8762FC938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0FF68D-98FC-0D4E-8C88-7D00D80D8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91DA52-5219-EB48-B396-16A8E5913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E8E250-5538-364A-A760-AB23A9A03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2480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4D542F-5C66-3642-A87F-0CAF3E96B0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5815BC-681E-B445-9654-8F96957D0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55579A-1541-6A44-93B5-779229760F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92299E6-8518-BF46-ADAF-DC8DF5875C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6D9085-C70D-9048-B2DA-3DF43924BB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801B805-8FA7-214F-B4B3-A6EFBF914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B57A9BE-C749-764E-B5E7-08772068D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36CED4B-1A78-D343-B5BE-F234CDA03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3628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4B2392-135E-F249-A3AA-6E199358FA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C7DE5CA-A712-F047-AD02-3A54E52D4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9F4A1B7-00D7-E646-B68A-9B79A7039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D297DD7-BFB2-D047-8DD1-44F061B60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3141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1511477-7083-0F49-BF50-68569A007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FAB8D5D-1B90-E84B-BEEA-9841E8006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94ACF62-F06F-EE49-9957-A345CB48E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72660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DD7C81-0B19-F14F-B4C8-2237B6177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2C2F07-AF3A-C647-9283-6107495825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DDC5512-A5E5-0B49-947A-F07E0902E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637552-C4B4-8C41-8FC8-A9EAA8CB6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926730-2194-4A48-AE6E-961638D6F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2FD8C5-7C0F-284F-87B8-01C86134F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21620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E17143-4F63-C14D-8F44-E5263E1E3A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4B3DEF3-9093-2C4C-8544-F56842BA6D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5B4783-3102-CE4F-88AF-C18F2512F3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1C9308-D018-0E49-93E8-F0895CA08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41D46B-6FF7-E74A-904F-758606FC3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54180E-EAFD-EA4B-BEDA-7B472B242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23015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850EF9-6CA7-6A41-9157-2AF1A6B06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5FB875-B053-E347-BA82-23D745BE87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AA7F64-AD4D-ED43-B57C-39BE610E0B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8FCB07-7DCA-D441-9B5B-EEC67A807199}" type="datetimeFigureOut">
              <a:rPr kumimoji="1" lang="zh-CN" altLang="en-US" smtClean="0"/>
              <a:t>2020/11/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30BD17-7680-3343-AC70-F644F00AD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D01340-A5B0-9641-9B15-50352545BC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C4884-A412-6E4F-83B5-5BE7EFEDFDC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95856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able&#10;&#10;Description automatically generated">
            <a:extLst>
              <a:ext uri="{FF2B5EF4-FFF2-40B4-BE49-F238E27FC236}">
                <a16:creationId xmlns:a16="http://schemas.microsoft.com/office/drawing/2014/main" id="{E1952CE8-DBFD-49F7-9ED2-9AC6DF1B48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1760" y="302009"/>
            <a:ext cx="5439003" cy="4730851"/>
          </a:xfrm>
          <a:prstGeom prst="rect">
            <a:avLst/>
          </a:prstGeom>
        </p:spPr>
      </p:pic>
      <p:pic>
        <p:nvPicPr>
          <p:cNvPr id="7" name="Picture 6" descr="Calendar&#10;&#10;Description automatically generated">
            <a:extLst>
              <a:ext uri="{FF2B5EF4-FFF2-40B4-BE49-F238E27FC236}">
                <a16:creationId xmlns:a16="http://schemas.microsoft.com/office/drawing/2014/main" id="{9DE48FAD-02B7-46B0-9651-850BAA1069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024" y="675649"/>
            <a:ext cx="6357574" cy="45837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CFDBCE1-27B0-4F4F-97F9-D8B414F597E8}"/>
              </a:ext>
            </a:extLst>
          </p:cNvPr>
          <p:cNvSpPr txBox="1"/>
          <p:nvPr/>
        </p:nvSpPr>
        <p:spPr>
          <a:xfrm>
            <a:off x="477647" y="5259381"/>
            <a:ext cx="620549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1</a:t>
            </a:r>
            <a:r>
              <a:rPr lang="en-GB" altLang="zh-CN" sz="1200" b="1" dirty="0"/>
              <a:t>.</a:t>
            </a:r>
            <a:r>
              <a:rPr lang="en-GB" altLang="zh-CN" sz="1200" dirty="0"/>
              <a:t>  </a:t>
            </a:r>
            <a:r>
              <a:rPr lang="en-GB" sz="1200" dirty="0"/>
              <a:t>Electropherograms—generated by the Agilent Technologies’ 2100 Bioanalyzer system using an RNA 6000 Nano kit—from wild-type </a:t>
            </a:r>
            <a:r>
              <a:rPr lang="en-GB" sz="1200" i="1" dirty="0"/>
              <a:t>C. elegans </a:t>
            </a:r>
            <a:r>
              <a:rPr lang="en-GB" sz="1200" dirty="0"/>
              <a:t>exposed to different concentrations of </a:t>
            </a:r>
            <a:r>
              <a:rPr lang="en-GB" sz="1200" dirty="0" err="1"/>
              <a:t>BaP</a:t>
            </a:r>
            <a:r>
              <a:rPr lang="en-GB" sz="1200" dirty="0"/>
              <a:t> (0, 5, and 20 </a:t>
            </a:r>
            <a:r>
              <a:rPr lang="en-GB" sz="1200" dirty="0" err="1"/>
              <a:t>μM</a:t>
            </a:r>
            <a:r>
              <a:rPr lang="en-GB" sz="1200" dirty="0"/>
              <a:t>) for 48 h, showing four RNA biological replicate samples for each group (A, B, C, and D). All samples contained DMSO (0.1% v/v). The peak closest to the 40-second mark is representative of the 18S ribosomal RNA fragment, and the peak closest to the 45-second mark is representative of the 26S ribosomal RNA fragment of </a:t>
            </a:r>
            <a:r>
              <a:rPr lang="en-GB" sz="1200" i="1" dirty="0"/>
              <a:t>C. elegans</a:t>
            </a:r>
            <a:r>
              <a:rPr lang="en-GB" sz="1200" dirty="0"/>
              <a:t>. The RNA integrity number (RIN) is also shown; RIN values usually range from 10 (intact) to 1 (totally degraded).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9BB1940-1ABE-43A1-AD70-1B7AF58E9401}"/>
              </a:ext>
            </a:extLst>
          </p:cNvPr>
          <p:cNvSpPr txBox="1"/>
          <p:nvPr/>
        </p:nvSpPr>
        <p:spPr>
          <a:xfrm>
            <a:off x="7081113" y="5129464"/>
            <a:ext cx="48196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2</a:t>
            </a:r>
            <a:r>
              <a:rPr lang="en-GB" altLang="zh-CN" sz="1200" b="1" dirty="0"/>
              <a:t>.</a:t>
            </a:r>
            <a:r>
              <a:rPr lang="en-GB" altLang="zh-CN" sz="1200" dirty="0"/>
              <a:t> A densitometry plot from the Agilent Technologies’ 2100 Bioanalyzer system using an RNA 6000 Nano of four RNA biological replicate samples from three groups of wild-type </a:t>
            </a:r>
            <a:r>
              <a:rPr lang="en-GB" altLang="zh-CN" sz="1200" i="1" dirty="0"/>
              <a:t>C. elegans </a:t>
            </a:r>
            <a:r>
              <a:rPr lang="en-GB" altLang="zh-CN" sz="1200" dirty="0"/>
              <a:t>exposed to different concentrations of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(0, 5, and 20 </a:t>
            </a:r>
            <a:r>
              <a:rPr lang="en-GB" altLang="zh-CN" sz="1200" dirty="0" err="1"/>
              <a:t>μM</a:t>
            </a:r>
            <a:r>
              <a:rPr lang="en-GB" altLang="zh-CN" sz="1200" dirty="0"/>
              <a:t>) for 48 h. All samples contained DMSO (0.1% v/v). The most prominent bands and the second-most prominent ones are representative of the 26S and the 18S ribosomal RNA fragments, respectively. L is the ladder column.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47819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A8DC7C0-ACDC-1E49-ABC5-C1F77A2C7B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17476"/>
            <a:ext cx="12192000" cy="4770494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45B99CCA-4AD1-1143-9D97-EE0F835D8364}"/>
              </a:ext>
            </a:extLst>
          </p:cNvPr>
          <p:cNvSpPr/>
          <p:nvPr/>
        </p:nvSpPr>
        <p:spPr>
          <a:xfrm>
            <a:off x="139700" y="457200"/>
            <a:ext cx="117816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zh-CN" dirty="0">
                <a:latin typeface="TimesNewRomanPSMT"/>
              </a:rPr>
              <a:t>Supplementary 3</a:t>
            </a:r>
            <a:r>
              <a:rPr lang="en-US" altLang="zh-CN" dirty="0">
                <a:latin typeface="TimesNewRomanPSMT"/>
              </a:rPr>
              <a:t>. </a:t>
            </a:r>
            <a:r>
              <a:rPr lang="en" altLang="zh-CN" dirty="0">
                <a:latin typeface="TimesNewRomanPSMT"/>
              </a:rPr>
              <a:t>A list of all genes assessed by qPCR, their sequence names, forward and reverse primer sequences names, forward and reverse primer sequences, length, melting temperature (Tm), and %GC content, in addition to the amplicon size of the product, and the optimal hydrolysis probe obtained from the </a:t>
            </a:r>
            <a:r>
              <a:rPr lang="en" altLang="zh-CN" dirty="0" err="1">
                <a:latin typeface="TimesNewRomanPSMT"/>
              </a:rPr>
              <a:t>RocheTM</a:t>
            </a:r>
            <a:r>
              <a:rPr lang="en" altLang="zh-CN" dirty="0">
                <a:latin typeface="TimesNewRomanPSMT"/>
              </a:rPr>
              <a:t> Diagnostics’ Universal </a:t>
            </a:r>
            <a:r>
              <a:rPr lang="en" altLang="zh-CN" dirty="0" err="1">
                <a:latin typeface="TimesNewRomanPSMT"/>
              </a:rPr>
              <a:t>ProbeLibrary</a:t>
            </a:r>
            <a:r>
              <a:rPr lang="en" altLang="zh-CN" dirty="0">
                <a:latin typeface="TimesNewRomanPSMT"/>
              </a:rPr>
              <a:t> Assay Design Centre web tool (</a:t>
            </a:r>
            <a:r>
              <a:rPr lang="en" altLang="zh-CN" dirty="0">
                <a:solidFill>
                  <a:srgbClr val="0260BF"/>
                </a:solidFill>
                <a:latin typeface="TimesNewRomanPSMT"/>
              </a:rPr>
              <a:t>https://</a:t>
            </a:r>
            <a:r>
              <a:rPr lang="en" altLang="zh-CN" dirty="0" err="1">
                <a:solidFill>
                  <a:srgbClr val="0260BF"/>
                </a:solidFill>
                <a:latin typeface="TimesNewRomanPSMT"/>
              </a:rPr>
              <a:t>lifescience.roche.com</a:t>
            </a:r>
            <a:r>
              <a:rPr lang="en" altLang="zh-CN" dirty="0">
                <a:solidFill>
                  <a:srgbClr val="0260BF"/>
                </a:solidFill>
                <a:latin typeface="TimesNewRomanPSMT"/>
              </a:rPr>
              <a:t>/</a:t>
            </a:r>
            <a:r>
              <a:rPr lang="en" altLang="zh-CN" dirty="0" err="1">
                <a:solidFill>
                  <a:srgbClr val="0260BF"/>
                </a:solidFill>
                <a:latin typeface="TimesNewRomanPSMT"/>
              </a:rPr>
              <a:t>global_en</a:t>
            </a:r>
            <a:r>
              <a:rPr lang="en" altLang="zh-CN" dirty="0">
                <a:solidFill>
                  <a:srgbClr val="0260BF"/>
                </a:solidFill>
                <a:latin typeface="TimesNewRomanPSMT"/>
              </a:rPr>
              <a:t>/brands/</a:t>
            </a:r>
            <a:r>
              <a:rPr lang="en" altLang="zh-CN" dirty="0" err="1">
                <a:solidFill>
                  <a:srgbClr val="0260BF"/>
                </a:solidFill>
                <a:latin typeface="TimesNewRomanPSMT"/>
              </a:rPr>
              <a:t>universal-probe-library.html#assay-design-center</a:t>
            </a:r>
            <a:r>
              <a:rPr lang="en" altLang="zh-CN" dirty="0">
                <a:latin typeface="TimesNewRomanPSMT"/>
              </a:rPr>
              <a:t>). </a:t>
            </a:r>
            <a:endParaRPr lang="en" altLang="zh-CN" dirty="0"/>
          </a:p>
        </p:txBody>
      </p:sp>
    </p:spTree>
    <p:extLst>
      <p:ext uri="{BB962C8B-B14F-4D97-AF65-F5344CB8AC3E}">
        <p14:creationId xmlns:p14="http://schemas.microsoft.com/office/powerpoint/2010/main" val="40793154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15">
            <a:extLst>
              <a:ext uri="{FF2B5EF4-FFF2-40B4-BE49-F238E27FC236}">
                <a16:creationId xmlns:a16="http://schemas.microsoft.com/office/drawing/2014/main" id="{7D1494BB-1B31-E749-8801-8E99047A63D1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16"/>
          <a:stretch/>
        </p:blipFill>
        <p:spPr bwMode="auto">
          <a:xfrm>
            <a:off x="1045845" y="472122"/>
            <a:ext cx="4023360" cy="275145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E9620E69-934A-C642-A49A-0ACC4C2C32B0}"/>
              </a:ext>
            </a:extLst>
          </p:cNvPr>
          <p:cNvSpPr txBox="1"/>
          <p:nvPr/>
        </p:nvSpPr>
        <p:spPr>
          <a:xfrm>
            <a:off x="690562" y="3892888"/>
            <a:ext cx="4733925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4</a:t>
            </a:r>
            <a:r>
              <a:rPr lang="en-GB" altLang="zh-CN" sz="1200" b="1" dirty="0"/>
              <a:t>.</a:t>
            </a:r>
            <a:r>
              <a:rPr lang="en-GB" altLang="zh-CN" sz="1200" dirty="0"/>
              <a:t> A principal component analysis of the RNA-</a:t>
            </a:r>
            <a:r>
              <a:rPr lang="en-GB" altLang="zh-CN" sz="1200" dirty="0" err="1"/>
              <a:t>seq</a:t>
            </a:r>
            <a:r>
              <a:rPr lang="en-GB" altLang="zh-CN" sz="1200" dirty="0"/>
              <a:t> data of the significantly and differentially regulated genes (&gt; 2-fold change, t-test, p ≤ 0.05, n = 3) of wild-type </a:t>
            </a:r>
            <a:r>
              <a:rPr lang="en-GB" altLang="zh-CN" sz="1200" i="1" dirty="0"/>
              <a:t>C. elegans </a:t>
            </a:r>
            <a:r>
              <a:rPr lang="en-GB" altLang="zh-CN" sz="1200" dirty="0"/>
              <a:t>exposed to different concentrations of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(0, 5, and 20 µM) for 48 h. All samples contained DMSO (0.1% v/v). The principal components were calculated using unit variance scaling and singular value decomposition with imputation. X and Y axes show principal component 1 and principal component 2 that explain 62.1% and 13.5% of the total variance, respectively. Prediction ellipses are such that with probability 0.95, a new observation from the same group will fall inside the ellipse. The analysis was performed using </a:t>
            </a:r>
            <a:r>
              <a:rPr lang="en-GB" altLang="zh-CN" sz="1200" dirty="0" err="1"/>
              <a:t>ClustVis</a:t>
            </a:r>
            <a:r>
              <a:rPr lang="en-GB" altLang="zh-CN" sz="1200" dirty="0"/>
              <a:t>™ web tool (</a:t>
            </a:r>
            <a:r>
              <a:rPr lang="en-GB" altLang="zh-CN" sz="1200" dirty="0" err="1"/>
              <a:t>Metsalu</a:t>
            </a:r>
            <a:r>
              <a:rPr lang="en-GB" altLang="zh-CN" sz="1200" dirty="0"/>
              <a:t> &amp; </a:t>
            </a:r>
            <a:r>
              <a:rPr lang="en-GB" altLang="zh-CN" sz="1200" dirty="0" err="1"/>
              <a:t>Vilo</a:t>
            </a:r>
            <a:r>
              <a:rPr lang="en-GB" altLang="zh-CN" sz="1200" dirty="0"/>
              <a:t>, 2015).</a:t>
            </a:r>
            <a:endParaRPr lang="zh-CN" altLang="zh-CN" sz="1200" dirty="0"/>
          </a:p>
          <a:p>
            <a:endParaRPr kumimoji="1" lang="zh-CN" altLang="en-US" sz="1200" dirty="0"/>
          </a:p>
        </p:txBody>
      </p:sp>
      <p:pic>
        <p:nvPicPr>
          <p:cNvPr id="8" name="Picture 116">
            <a:extLst>
              <a:ext uri="{FF2B5EF4-FFF2-40B4-BE49-F238E27FC236}">
                <a16:creationId xmlns:a16="http://schemas.microsoft.com/office/drawing/2014/main" id="{83E753B4-4011-2643-8814-CAF6852A6E7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2745" y="137159"/>
            <a:ext cx="4297680" cy="342138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31C42944-3D68-6946-A8B0-ABEFFBBF6D0D}"/>
              </a:ext>
            </a:extLst>
          </p:cNvPr>
          <p:cNvSpPr txBox="1"/>
          <p:nvPr/>
        </p:nvSpPr>
        <p:spPr>
          <a:xfrm>
            <a:off x="6461760" y="4063364"/>
            <a:ext cx="481965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5</a:t>
            </a:r>
            <a:r>
              <a:rPr lang="en-GB" altLang="zh-CN" sz="1200" b="1" dirty="0"/>
              <a:t>.</a:t>
            </a:r>
            <a:r>
              <a:rPr lang="en-GB" altLang="zh-CN" sz="1200" dirty="0"/>
              <a:t> A heatmap graph of the RNA-</a:t>
            </a:r>
            <a:r>
              <a:rPr lang="en-GB" altLang="zh-CN" sz="1200" dirty="0" err="1"/>
              <a:t>seq</a:t>
            </a:r>
            <a:r>
              <a:rPr lang="en-GB" altLang="zh-CN" sz="1200" dirty="0"/>
              <a:t> data of 312 significantly and differentially regulated genes (&gt; 2-fold change, t-test, p ≤ 0.05, n = 3) of wild-type </a:t>
            </a:r>
            <a:r>
              <a:rPr lang="en-GB" altLang="zh-CN" sz="1200" i="1" dirty="0"/>
              <a:t>C. elegans</a:t>
            </a:r>
            <a:r>
              <a:rPr lang="en-GB" altLang="zh-CN" sz="1200" dirty="0"/>
              <a:t> exposed to different concentrations of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(0, 5, and 20 µM) for 48 h. All samples contained DMSO (0.1% v/v). Unit variance scaling is applied to rows (genes). Imputation is used for missing value estimation. Both rows (genes) and columns (samples) are clustered using correlation distance and average linkage; 312 rows (genes), 9 columns (samples). The graph was drawn using </a:t>
            </a:r>
            <a:r>
              <a:rPr lang="en-GB" altLang="zh-CN" sz="1200" dirty="0" err="1"/>
              <a:t>ClustVis</a:t>
            </a:r>
            <a:r>
              <a:rPr lang="en-GB" altLang="zh-CN" sz="1200" dirty="0"/>
              <a:t>™ web tool (</a:t>
            </a:r>
            <a:r>
              <a:rPr lang="en-GB" altLang="zh-CN" sz="1200" dirty="0" err="1"/>
              <a:t>Metsalu</a:t>
            </a:r>
            <a:r>
              <a:rPr lang="en-GB" altLang="zh-CN" sz="1200" dirty="0"/>
              <a:t> &amp; </a:t>
            </a:r>
            <a:r>
              <a:rPr lang="en-GB" altLang="zh-CN" sz="1200" dirty="0" err="1"/>
              <a:t>Vilo</a:t>
            </a:r>
            <a:r>
              <a:rPr lang="en-GB" altLang="zh-CN" sz="1200" dirty="0"/>
              <a:t>, 2015).</a:t>
            </a:r>
            <a:endParaRPr lang="zh-CN" altLang="zh-CN" sz="1200" dirty="0"/>
          </a:p>
          <a:p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5405075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5" name="Picture 122">
            <a:extLst>
              <a:ext uri="{FF2B5EF4-FFF2-40B4-BE49-F238E27FC236}">
                <a16:creationId xmlns:a16="http://schemas.microsoft.com/office/drawing/2014/main" id="{7973B5A8-1638-9848-92F6-51C909C7F9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25" y="228600"/>
            <a:ext cx="2628900" cy="24610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124">
            <a:extLst>
              <a:ext uri="{FF2B5EF4-FFF2-40B4-BE49-F238E27FC236}">
                <a16:creationId xmlns:a16="http://schemas.microsoft.com/office/drawing/2014/main" id="{023AAFCB-CA62-D14F-B26D-2FFC6BDDA8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2079" y="166633"/>
            <a:ext cx="2635200" cy="2523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125">
            <a:extLst>
              <a:ext uri="{FF2B5EF4-FFF2-40B4-BE49-F238E27FC236}">
                <a16:creationId xmlns:a16="http://schemas.microsoft.com/office/drawing/2014/main" id="{0ABC3362-7C64-414F-A07C-4C5EC9A39B3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0333" y="168571"/>
            <a:ext cx="2635200" cy="25230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127">
            <a:extLst>
              <a:ext uri="{FF2B5EF4-FFF2-40B4-BE49-F238E27FC236}">
                <a16:creationId xmlns:a16="http://schemas.microsoft.com/office/drawing/2014/main" id="{725FBE24-EB65-ED4F-9ADC-236C693FCA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8587" y="144502"/>
            <a:ext cx="2635200" cy="2579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123">
            <a:extLst>
              <a:ext uri="{FF2B5EF4-FFF2-40B4-BE49-F238E27FC236}">
                <a16:creationId xmlns:a16="http://schemas.microsoft.com/office/drawing/2014/main" id="{67FB07C7-9DAB-8347-BAA2-6488AF7AC5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1988" y="2707325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129">
            <a:extLst>
              <a:ext uri="{FF2B5EF4-FFF2-40B4-BE49-F238E27FC236}">
                <a16:creationId xmlns:a16="http://schemas.microsoft.com/office/drawing/2014/main" id="{4A1C30C9-BF78-9349-8334-4FA1BC3D7B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848" y="2723634"/>
            <a:ext cx="2512252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130">
            <a:extLst>
              <a:ext uri="{FF2B5EF4-FFF2-40B4-BE49-F238E27FC236}">
                <a16:creationId xmlns:a16="http://schemas.microsoft.com/office/drawing/2014/main" id="{5A960C96-7151-574C-AA20-5070C9B9D2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3763" y="2694900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7" name="Picture 128">
            <a:extLst>
              <a:ext uri="{FF2B5EF4-FFF2-40B4-BE49-F238E27FC236}">
                <a16:creationId xmlns:a16="http://schemas.microsoft.com/office/drawing/2014/main" id="{B67CD53B-3BC7-884C-BD82-49548663F4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1398" y="2707325"/>
            <a:ext cx="253059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10">
            <a:extLst>
              <a:ext uri="{FF2B5EF4-FFF2-40B4-BE49-F238E27FC236}">
                <a16:creationId xmlns:a16="http://schemas.microsoft.com/office/drawing/2014/main" id="{263EFDBB-D764-FC49-8E85-7B593F9766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6" name="Rectangle 11">
            <a:extLst>
              <a:ext uri="{FF2B5EF4-FFF2-40B4-BE49-F238E27FC236}">
                <a16:creationId xmlns:a16="http://schemas.microsoft.com/office/drawing/2014/main" id="{31E73663-07FF-FE48-BB6F-2487BBDA7B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924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7" name="Rectangle 13">
            <a:extLst>
              <a:ext uri="{FF2B5EF4-FFF2-40B4-BE49-F238E27FC236}">
                <a16:creationId xmlns:a16="http://schemas.microsoft.com/office/drawing/2014/main" id="{4010E279-D2D0-884E-9494-1791632042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924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8" name="Rectangle 14">
            <a:extLst>
              <a:ext uri="{FF2B5EF4-FFF2-40B4-BE49-F238E27FC236}">
                <a16:creationId xmlns:a16="http://schemas.microsoft.com/office/drawing/2014/main" id="{958B369D-01B5-C547-B22A-0C6CE6F3C6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143129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02D2753-2AA1-EC4C-B287-35C647807C98}"/>
              </a:ext>
            </a:extLst>
          </p:cNvPr>
          <p:cNvSpPr txBox="1"/>
          <p:nvPr/>
        </p:nvSpPr>
        <p:spPr>
          <a:xfrm>
            <a:off x="1039147" y="5300978"/>
            <a:ext cx="751627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Supplementary 6</a:t>
            </a:r>
            <a:r>
              <a:rPr lang="en-GB" altLang="zh-CN" sz="1400" b="1" dirty="0"/>
              <a:t>. </a:t>
            </a:r>
            <a:r>
              <a:rPr lang="en-GB" altLang="zh-CN" sz="1400" dirty="0"/>
              <a:t>Expression difference (fold) comparison of eight </a:t>
            </a:r>
            <a:r>
              <a:rPr lang="en-GB" altLang="zh-CN" sz="1400" i="1" dirty="0"/>
              <a:t>cyp-35</a:t>
            </a:r>
            <a:r>
              <a:rPr lang="en-GB" altLang="zh-CN" sz="1400" dirty="0"/>
              <a:t> genes between RNA-</a:t>
            </a:r>
            <a:r>
              <a:rPr lang="en-GB" altLang="zh-CN" sz="1400" dirty="0" err="1"/>
              <a:t>seq</a:t>
            </a:r>
            <a:r>
              <a:rPr lang="en-GB" altLang="zh-CN" sz="1400" dirty="0"/>
              <a:t> (red) and qPCR validation (blue) results after exposure of wild-type </a:t>
            </a:r>
            <a:r>
              <a:rPr lang="en-GB" altLang="zh-CN" sz="1400" i="1" dirty="0"/>
              <a:t>C. elegans </a:t>
            </a:r>
            <a:r>
              <a:rPr lang="en-GB" altLang="zh-CN" sz="1400" dirty="0"/>
              <a:t>to 5 and 20 µM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for 48 h, in comparison to those exposed to 0 µM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(control; white). All samples contained DMSO (0.1% v/v). Note the divergence in the expression difference (fold) scale between graphs, but the conserved overall trend and fold-change. Error bars represent SEM, n = 3 per condition.</a:t>
            </a:r>
            <a:endParaRPr lang="zh-CN" altLang="zh-CN" sz="1400" dirty="0"/>
          </a:p>
          <a:p>
            <a:endParaRPr kumimoji="1" lang="zh-CN" altLang="en-US" sz="1400" dirty="0"/>
          </a:p>
        </p:txBody>
      </p:sp>
      <p:sp>
        <p:nvSpPr>
          <p:cNvPr id="10" name="Rectangle 22">
            <a:extLst>
              <a:ext uri="{FF2B5EF4-FFF2-40B4-BE49-F238E27FC236}">
                <a16:creationId xmlns:a16="http://schemas.microsoft.com/office/drawing/2014/main" id="{6BBDA456-E0F5-9C41-9A29-800D0C05F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GB" altLang="zh-CN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endParaRPr kumimoji="0" lang="en-GB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23">
            <a:extLst>
              <a:ext uri="{FF2B5EF4-FFF2-40B4-BE49-F238E27FC236}">
                <a16:creationId xmlns:a16="http://schemas.microsoft.com/office/drawing/2014/main" id="{DF51DCDC-97F1-C04D-B17D-C0A046E4BD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924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GB" altLang="zh-CN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endParaRPr kumimoji="0" lang="en-GB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24">
            <a:extLst>
              <a:ext uri="{FF2B5EF4-FFF2-40B4-BE49-F238E27FC236}">
                <a16:creationId xmlns:a16="http://schemas.microsoft.com/office/drawing/2014/main" id="{C492C8DC-A63F-3446-85E8-593F7CE045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0424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GB" altLang="zh-CN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endParaRPr kumimoji="0" lang="en-GB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18428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33">
            <a:extLst>
              <a:ext uri="{FF2B5EF4-FFF2-40B4-BE49-F238E27FC236}">
                <a16:creationId xmlns:a16="http://schemas.microsoft.com/office/drawing/2014/main" id="{D397A2B8-5C5D-B345-A2DF-C4E520C229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305" y="216483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31">
            <a:extLst>
              <a:ext uri="{FF2B5EF4-FFF2-40B4-BE49-F238E27FC236}">
                <a16:creationId xmlns:a16="http://schemas.microsoft.com/office/drawing/2014/main" id="{37CD408D-4638-FA4B-B779-49387F067D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3725" y="212048"/>
            <a:ext cx="2626445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38">
            <a:extLst>
              <a:ext uri="{FF2B5EF4-FFF2-40B4-BE49-F238E27FC236}">
                <a16:creationId xmlns:a16="http://schemas.microsoft.com/office/drawing/2014/main" id="{ECF7B459-021E-B242-A7CB-576023FA9C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2979" y="212172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36">
            <a:extLst>
              <a:ext uri="{FF2B5EF4-FFF2-40B4-BE49-F238E27FC236}">
                <a16:creationId xmlns:a16="http://schemas.microsoft.com/office/drawing/2014/main" id="{D2984BA5-2AB5-E947-B95F-72CDB6DF8C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94573" y="212048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35">
            <a:extLst>
              <a:ext uri="{FF2B5EF4-FFF2-40B4-BE49-F238E27FC236}">
                <a16:creationId xmlns:a16="http://schemas.microsoft.com/office/drawing/2014/main" id="{237DFBC0-2919-2C4A-B186-82D0773C2F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3725" y="2666413"/>
            <a:ext cx="2606698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56">
            <a:extLst>
              <a:ext uri="{FF2B5EF4-FFF2-40B4-BE49-F238E27FC236}">
                <a16:creationId xmlns:a16="http://schemas.microsoft.com/office/drawing/2014/main" id="{B04C8B30-55E2-5749-8E61-3053DA0576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2979" y="2675283"/>
            <a:ext cx="2568080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41">
            <a:extLst>
              <a:ext uri="{FF2B5EF4-FFF2-40B4-BE49-F238E27FC236}">
                <a16:creationId xmlns:a16="http://schemas.microsoft.com/office/drawing/2014/main" id="{B78EDAC3-9D70-DF4A-8B74-1D6DC7D8B2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181" y="2670848"/>
            <a:ext cx="2606698" cy="245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ADC6A0B-0D18-2245-8255-44BE8D0E4288}"/>
              </a:ext>
            </a:extLst>
          </p:cNvPr>
          <p:cNvSpPr txBox="1"/>
          <p:nvPr/>
        </p:nvSpPr>
        <p:spPr>
          <a:xfrm>
            <a:off x="8201025" y="3125324"/>
            <a:ext cx="341947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7</a:t>
            </a:r>
            <a:r>
              <a:rPr lang="en-GB" altLang="zh-CN" sz="1200" b="1" dirty="0"/>
              <a:t>. </a:t>
            </a:r>
            <a:r>
              <a:rPr lang="en-GB" altLang="zh-CN" sz="1200" dirty="0"/>
              <a:t>Expression difference (fold) comparison of seven genes between RNA-</a:t>
            </a:r>
            <a:r>
              <a:rPr lang="en-GB" altLang="zh-CN" sz="1200" dirty="0" err="1"/>
              <a:t>seq</a:t>
            </a:r>
            <a:r>
              <a:rPr lang="en-GB" altLang="zh-CN" sz="1200" dirty="0"/>
              <a:t> (red) and qPCR validation (blue) results after exposure of wild-type </a:t>
            </a:r>
            <a:r>
              <a:rPr lang="en-GB" altLang="zh-CN" sz="1200" i="1" dirty="0"/>
              <a:t>C. elegans</a:t>
            </a:r>
            <a:r>
              <a:rPr lang="en-GB" altLang="zh-CN" sz="1200" dirty="0"/>
              <a:t> to 5 and 20 µM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for 48 h, in comparison to those exposed to 0 µM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(control; white). All samples contained DMSO (0.1% v/v). Note the divergence in expression difference (fold) scale between graphs, but the conserved overall trend and fold-change. Error bars represent SEM, n = 3 per condition.</a:t>
            </a:r>
            <a:endParaRPr lang="zh-CN" altLang="zh-CN" sz="1200" dirty="0"/>
          </a:p>
          <a:p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779197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35C4881-F3DA-44EF-BC9D-DDD406D40F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5253893"/>
              </p:ext>
            </p:extLst>
          </p:nvPr>
        </p:nvGraphicFramePr>
        <p:xfrm>
          <a:off x="2301353" y="522718"/>
          <a:ext cx="7589293" cy="468065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773376">
                  <a:extLst>
                    <a:ext uri="{9D8B030D-6E8A-4147-A177-3AD203B41FA5}">
                      <a16:colId xmlns:a16="http://schemas.microsoft.com/office/drawing/2014/main" val="126972154"/>
                    </a:ext>
                  </a:extLst>
                </a:gridCol>
                <a:gridCol w="1239294">
                  <a:extLst>
                    <a:ext uri="{9D8B030D-6E8A-4147-A177-3AD203B41FA5}">
                      <a16:colId xmlns:a16="http://schemas.microsoft.com/office/drawing/2014/main" val="1442262347"/>
                    </a:ext>
                  </a:extLst>
                </a:gridCol>
                <a:gridCol w="1310508">
                  <a:extLst>
                    <a:ext uri="{9D8B030D-6E8A-4147-A177-3AD203B41FA5}">
                      <a16:colId xmlns:a16="http://schemas.microsoft.com/office/drawing/2014/main" val="935749357"/>
                    </a:ext>
                  </a:extLst>
                </a:gridCol>
                <a:gridCol w="1266115">
                  <a:extLst>
                    <a:ext uri="{9D8B030D-6E8A-4147-A177-3AD203B41FA5}">
                      <a16:colId xmlns:a16="http://schemas.microsoft.com/office/drawing/2014/main" val="1253993876"/>
                    </a:ext>
                  </a:extLst>
                </a:gridCol>
              </a:tblGrid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 Ter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 I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BaP Exposu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2889502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5 µ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20 µ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51172605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Ontology: Molecular Functio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036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44046866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Catalytic activit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038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0125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4.04e-5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77129992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Transferase activit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1674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309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0108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325912"/>
                  </a:ext>
                </a:extLst>
              </a:tr>
              <a:tr h="50658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Transferase activity, transferring glycosyl group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167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1.05e-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2.56e-8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10799692"/>
                  </a:ext>
                </a:extLst>
              </a:tr>
              <a:tr h="50658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Transferase activity, transferring hexosyl group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167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1.32e-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2.56e-8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77884586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Oxidoreductase activit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1649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075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98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40366222"/>
                  </a:ext>
                </a:extLst>
              </a:tr>
              <a:tr h="76537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Oxidoreductase activity, acting on paired donors, with incorporation or reduction of molecular oxyge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167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6.82e-5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3.94e-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16187913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Ontology: Biological Proces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0815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17062583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Response to chemical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422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—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153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77674849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Response to xenobiotic stimulu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094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1.05e-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3.94e-6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85508295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Metabolic proces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081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574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—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15889179"/>
                  </a:ext>
                </a:extLst>
              </a:tr>
              <a:tr h="26382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Oxidation-reduction proces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GO:00551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X (0.00598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</a:rPr>
                        <a:t>X (0.0758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6993708"/>
                  </a:ext>
                </a:extLst>
              </a:tr>
            </a:tbl>
          </a:graphicData>
        </a:graphic>
      </p:graphicFrame>
      <p:sp>
        <p:nvSpPr>
          <p:cNvPr id="6" name="文本框 10">
            <a:extLst>
              <a:ext uri="{FF2B5EF4-FFF2-40B4-BE49-F238E27FC236}">
                <a16:creationId xmlns:a16="http://schemas.microsoft.com/office/drawing/2014/main" id="{E1F97C65-2BF8-4DAC-BE41-72335D4112DD}"/>
              </a:ext>
            </a:extLst>
          </p:cNvPr>
          <p:cNvSpPr txBox="1"/>
          <p:nvPr/>
        </p:nvSpPr>
        <p:spPr>
          <a:xfrm>
            <a:off x="1482497" y="5511364"/>
            <a:ext cx="92270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upplementary 8</a:t>
            </a:r>
            <a:r>
              <a:rPr lang="en-GB" altLang="zh-CN" sz="1200" b="1" dirty="0"/>
              <a:t>. </a:t>
            </a:r>
            <a:r>
              <a:rPr lang="en-GB" altLang="zh-CN" sz="1200" dirty="0"/>
              <a:t>Top modified GO terms when </a:t>
            </a:r>
            <a:r>
              <a:rPr lang="en-GB" altLang="zh-CN" sz="1200" i="1" dirty="0"/>
              <a:t>C. elegans </a:t>
            </a:r>
            <a:r>
              <a:rPr lang="en-GB" altLang="zh-CN" sz="1200" dirty="0"/>
              <a:t>exposed to different </a:t>
            </a:r>
            <a:r>
              <a:rPr lang="en-GB" altLang="zh-CN" sz="1200" dirty="0" err="1"/>
              <a:t>BaP</a:t>
            </a:r>
            <a:r>
              <a:rPr lang="en-GB" altLang="zh-CN" sz="1200" dirty="0"/>
              <a:t> doses. </a:t>
            </a:r>
            <a:r>
              <a:rPr lang="en-GB" sz="1200" dirty="0"/>
              <a:t>X indicates enrichment. Numbers in parentheses are p-values. "—" indicates no enrichment. GO ID refers to gene ontology identification number.</a:t>
            </a:r>
          </a:p>
          <a:p>
            <a:endParaRPr lang="zh-CN" altLang="zh-CN" sz="1200" i="1" dirty="0"/>
          </a:p>
          <a:p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090978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矩形 37">
            <a:extLst>
              <a:ext uri="{FF2B5EF4-FFF2-40B4-BE49-F238E27FC236}">
                <a16:creationId xmlns:a16="http://schemas.microsoft.com/office/drawing/2014/main" id="{D224F1A0-1D66-044D-AA1D-2BF61794F035}"/>
              </a:ext>
            </a:extLst>
          </p:cNvPr>
          <p:cNvSpPr/>
          <p:nvPr/>
        </p:nvSpPr>
        <p:spPr>
          <a:xfrm>
            <a:off x="7320357" y="2136338"/>
            <a:ext cx="4498395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Supplementary 9</a:t>
            </a:r>
            <a:r>
              <a:rPr lang="en-GB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A maximum likelihood cladogram showing the relationships between the different UDP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-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Glucuronosyltransferases (UGTs) of </a:t>
            </a:r>
            <a:r>
              <a:rPr lang="en-GB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C. elegans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and </a:t>
            </a:r>
            <a:r>
              <a:rPr lang="en-GB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Homo sapiens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: the </a:t>
            </a:r>
            <a:r>
              <a:rPr lang="en-GB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C. elegans’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significantly (t-test, p ≤ 0.05, n = 3) upregulated UGTs’ (orange), and </a:t>
            </a:r>
            <a:r>
              <a:rPr lang="en-GB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Homo sapiens’ 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main benzo[</a:t>
            </a:r>
            <a:r>
              <a:rPr lang="en-GB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a</a:t>
            </a:r>
            <a:r>
              <a:rPr lang="en-GB" altLang="zh-CN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]pyrene metabolisers in human lung cell (purple). The tree has been generated using MEGA software, version 7.0.26.</a:t>
            </a:r>
            <a:endParaRPr lang="zh-CN" altLang="zh-CN" dirty="0">
              <a:solidFill>
                <a:srgbClr val="000000"/>
              </a:solidFill>
              <a:latin typeface="Times New Roman" panose="02020603050405020304" pitchFamily="18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pic>
        <p:nvPicPr>
          <p:cNvPr id="6" name="图形 5">
            <a:extLst>
              <a:ext uri="{FF2B5EF4-FFF2-40B4-BE49-F238E27FC236}">
                <a16:creationId xmlns:a16="http://schemas.microsoft.com/office/drawing/2014/main" id="{7733A14E-DE47-064B-9035-421FFEFBF85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l="13712" t="11386" r="33354" b="9363"/>
          <a:stretch/>
        </p:blipFill>
        <p:spPr>
          <a:xfrm>
            <a:off x="164386" y="0"/>
            <a:ext cx="6883686" cy="6870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53306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85">
            <a:extLst>
              <a:ext uri="{FF2B5EF4-FFF2-40B4-BE49-F238E27FC236}">
                <a16:creationId xmlns:a16="http://schemas.microsoft.com/office/drawing/2014/main" id="{FF503F17-9BDD-2D4D-8F9C-E8A41518846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2625" y="2725785"/>
            <a:ext cx="3348000" cy="260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1254">
            <a:extLst>
              <a:ext uri="{FF2B5EF4-FFF2-40B4-BE49-F238E27FC236}">
                <a16:creationId xmlns:a16="http://schemas.microsoft.com/office/drawing/2014/main" id="{893C1FEE-F779-2C4C-B83B-954C74044DAA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0625" y="2725785"/>
            <a:ext cx="3348000" cy="260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1275">
            <a:extLst>
              <a:ext uri="{FF2B5EF4-FFF2-40B4-BE49-F238E27FC236}">
                <a16:creationId xmlns:a16="http://schemas.microsoft.com/office/drawing/2014/main" id="{C1F7EC5E-19C7-FB4C-9D60-51E34D2126C6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5395" y="185287"/>
            <a:ext cx="3593989" cy="260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1250">
            <a:extLst>
              <a:ext uri="{FF2B5EF4-FFF2-40B4-BE49-F238E27FC236}">
                <a16:creationId xmlns:a16="http://schemas.microsoft.com/office/drawing/2014/main" id="{8D143D97-9C2B-3A4F-9932-67AA49F3CCC4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9355" y="185287"/>
            <a:ext cx="3593989" cy="260640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2AAA551-CEC3-6946-A6A4-7AFDFF453F14}"/>
              </a:ext>
            </a:extLst>
          </p:cNvPr>
          <p:cNvSpPr txBox="1"/>
          <p:nvPr/>
        </p:nvSpPr>
        <p:spPr>
          <a:xfrm>
            <a:off x="514350" y="5286375"/>
            <a:ext cx="1117282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Supplementary 10</a:t>
            </a:r>
            <a:r>
              <a:rPr lang="en-GB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. </a:t>
            </a:r>
            <a:r>
              <a:rPr lang="en-GB" altLang="zh-CN" sz="1400" dirty="0"/>
              <a:t>The brood size and percentage survival of wild-type </a:t>
            </a:r>
            <a:r>
              <a:rPr lang="en-GB" altLang="zh-CN" sz="1400" i="1" dirty="0"/>
              <a:t>C. elegans</a:t>
            </a:r>
            <a:r>
              <a:rPr lang="en-GB" altLang="zh-CN" sz="1400" dirty="0"/>
              <a:t> and cyp-35 knockout (KO) strain that were exposed to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(0 and 40 µM).</a:t>
            </a:r>
            <a:r>
              <a:rPr lang="zh-CN" altLang="zh-CN" sz="1400" dirty="0"/>
              <a:t> </a:t>
            </a:r>
            <a:r>
              <a:rPr lang="en-US" altLang="zh-CN" sz="1400" dirty="0"/>
              <a:t>(A-B) </a:t>
            </a:r>
            <a:r>
              <a:rPr lang="en-GB" altLang="zh-CN" sz="1400" dirty="0"/>
              <a:t>Wild-type </a:t>
            </a:r>
            <a:r>
              <a:rPr lang="en-GB" altLang="zh-CN" sz="1400" i="1" dirty="0"/>
              <a:t>C. elegans</a:t>
            </a:r>
            <a:r>
              <a:rPr lang="en-GB" altLang="zh-CN" sz="1400" dirty="0"/>
              <a:t> and </a:t>
            </a:r>
            <a:r>
              <a:rPr lang="en-GB" altLang="zh-CN" sz="1400" i="1" dirty="0"/>
              <a:t>cyp-35</a:t>
            </a:r>
            <a:r>
              <a:rPr lang="en-GB" altLang="zh-CN" sz="1400" dirty="0"/>
              <a:t> knockout (KO) strain were exposed to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(0 and 40 µM) for 8 days, and the average daily number of viable larvae was counted and cumulatively added during the egg laying phase, which is 6 days, (starting at day 4 from L1) and are labelled 1 – 6 on the graphs. All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doses contained DMSO (0.1% v/v). The number of viable larvae was counted every 24 h. Error bars represent SEM. Statistical analysis was performed using a two-way ANOVA, followed by a </a:t>
            </a:r>
            <a:r>
              <a:rPr lang="en-GB" altLang="zh-CN" sz="1400" dirty="0" err="1"/>
              <a:t>Sidak’s</a:t>
            </a:r>
            <a:r>
              <a:rPr lang="en-GB" altLang="zh-CN" sz="1400" dirty="0"/>
              <a:t> multiple comparisons test, n = 24 per condition. (C-D) All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concentrations contained DMSO (0.1% v/v). The worms were scored every 24 h until all worms were dead. Statistical analysis was performed using the log-rank (Mantel-Cox) test, n = 200 per </a:t>
            </a:r>
            <a:r>
              <a:rPr lang="en-GB" altLang="zh-CN" sz="1400" dirty="0" err="1"/>
              <a:t>BaP</a:t>
            </a:r>
            <a:r>
              <a:rPr lang="en-GB" altLang="zh-CN" sz="1400" dirty="0"/>
              <a:t> concentration per strain. </a:t>
            </a:r>
            <a:endParaRPr lang="zh-CN" altLang="en-US" sz="1400" dirty="0"/>
          </a:p>
          <a:p>
            <a:endParaRPr kumimoji="1" lang="zh-CN" altLang="en-US" sz="1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73FD0B-D234-824D-B290-A33EFA131179}"/>
              </a:ext>
            </a:extLst>
          </p:cNvPr>
          <p:cNvSpPr txBox="1"/>
          <p:nvPr/>
        </p:nvSpPr>
        <p:spPr>
          <a:xfrm>
            <a:off x="2601133" y="186105"/>
            <a:ext cx="355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A.</a:t>
            </a:r>
            <a:endParaRPr kumimoji="1"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EAA1006-FA71-654F-9326-D164E922FD5B}"/>
              </a:ext>
            </a:extLst>
          </p:cNvPr>
          <p:cNvSpPr txBox="1"/>
          <p:nvPr/>
        </p:nvSpPr>
        <p:spPr>
          <a:xfrm>
            <a:off x="6006369" y="186105"/>
            <a:ext cx="355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B.</a:t>
            </a:r>
            <a:endParaRPr kumimoji="1"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14DEC91-0EB3-D24E-A89C-EE4E1756B0D3}"/>
              </a:ext>
            </a:extLst>
          </p:cNvPr>
          <p:cNvSpPr txBox="1"/>
          <p:nvPr/>
        </p:nvSpPr>
        <p:spPr>
          <a:xfrm>
            <a:off x="2601132" y="2792144"/>
            <a:ext cx="355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C.</a:t>
            </a:r>
            <a:endParaRPr kumimoji="1"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E79A3C2-91B2-B84C-9A05-3CE0F11786E3}"/>
              </a:ext>
            </a:extLst>
          </p:cNvPr>
          <p:cNvSpPr txBox="1"/>
          <p:nvPr/>
        </p:nvSpPr>
        <p:spPr>
          <a:xfrm>
            <a:off x="6006368" y="2792144"/>
            <a:ext cx="355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D.</a:t>
            </a:r>
            <a:endParaRPr kumimoji="1"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168509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6</TotalTime>
  <Words>1301</Words>
  <Application>Microsoft Office PowerPoint</Application>
  <PresentationFormat>Widescreen</PresentationFormat>
  <Paragraphs>67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DengXian</vt:lpstr>
      <vt:lpstr>DengXian Light</vt:lpstr>
      <vt:lpstr>Arial</vt:lpstr>
      <vt:lpstr>Calibri</vt:lpstr>
      <vt:lpstr>Times New Roman</vt:lpstr>
      <vt:lpstr>TimesNewRomanPSMT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, Yuzhi</dc:creator>
  <cp:lastModifiedBy>Chen, Yuzhi</cp:lastModifiedBy>
  <cp:revision>4</cp:revision>
  <dcterms:created xsi:type="dcterms:W3CDTF">2020-06-04T12:22:52Z</dcterms:created>
  <dcterms:modified xsi:type="dcterms:W3CDTF">2020-11-05T11:18:47Z</dcterms:modified>
</cp:coreProperties>
</file>